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210" d="100"/>
          <a:sy n="210" d="100"/>
        </p:scale>
        <p:origin x="2222" y="270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19F8D-8156-4809-8A20-659B7CB69968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2666F-CD00-4A3E-B9A6-3DDA4B68D2B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19F8D-8156-4809-8A20-659B7CB69968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2666F-CD00-4A3E-B9A6-3DDA4B68D2B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19F8D-8156-4809-8A20-659B7CB69968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2666F-CD00-4A3E-B9A6-3DDA4B68D2B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19F8D-8156-4809-8A20-659B7CB69968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2666F-CD00-4A3E-B9A6-3DDA4B68D2B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19F8D-8156-4809-8A20-659B7CB69968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2666F-CD00-4A3E-B9A6-3DDA4B68D2B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19F8D-8156-4809-8A20-659B7CB69968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2666F-CD00-4A3E-B9A6-3DDA4B68D2B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19F8D-8156-4809-8A20-659B7CB69968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2666F-CD00-4A3E-B9A6-3DDA4B68D2B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19F8D-8156-4809-8A20-659B7CB69968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2666F-CD00-4A3E-B9A6-3DDA4B68D2B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19F8D-8156-4809-8A20-659B7CB69968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2666F-CD00-4A3E-B9A6-3DDA4B68D2B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19F8D-8156-4809-8A20-659B7CB69968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2666F-CD00-4A3E-B9A6-3DDA4B68D2B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19F8D-8156-4809-8A20-659B7CB69968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2666F-CD00-4A3E-B9A6-3DDA4B68D2B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F19F8D-8156-4809-8A20-659B7CB69968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D2666F-CD00-4A3E-B9A6-3DDA4B68D2B4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071536" y="500041"/>
          <a:ext cx="7643868" cy="4714911"/>
        </p:xfrm>
        <a:graphic>
          <a:graphicData uri="http://schemas.openxmlformats.org/drawingml/2006/table">
            <a:tbl>
              <a:tblPr/>
              <a:tblGrid>
                <a:gridCol w="632791"/>
                <a:gridCol w="619795"/>
                <a:gridCol w="749765"/>
                <a:gridCol w="627918"/>
                <a:gridCol w="613297"/>
                <a:gridCol w="631168"/>
                <a:gridCol w="631168"/>
                <a:gridCol w="634417"/>
                <a:gridCol w="615733"/>
                <a:gridCol w="629543"/>
                <a:gridCol w="627918"/>
                <a:gridCol w="630355"/>
              </a:tblGrid>
              <a:tr h="587260"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 dirty="0">
                          <a:latin typeface="Times New Roman"/>
                          <a:ea typeface="Times New Roman"/>
                          <a:cs typeface="Times New Roman"/>
                        </a:rPr>
                        <a:t>A1 </a:t>
                      </a:r>
                      <a:endParaRPr lang="en-US" sz="1100" dirty="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 dirty="0">
                          <a:latin typeface="Times New Roman"/>
                          <a:ea typeface="Times New Roman"/>
                          <a:cs typeface="Times New Roman"/>
                        </a:rPr>
                        <a:t>Negative Control </a:t>
                      </a:r>
                      <a:endParaRPr lang="en-U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2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extrin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3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Malt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4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Trehal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399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5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Cellobi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6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entiobi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7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Sucr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8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Turan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9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Stachy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10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Positive Control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marL="1270" marR="3175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11 pH 6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  <a:tc>
                  <a:txBody>
                    <a:bodyPr/>
                    <a:lstStyle/>
                    <a:p>
                      <a:pPr marL="1270" marR="319405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12 pH 5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</a:tr>
              <a:tr h="593461"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B1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Raffin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B2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Segoe UI Symbol"/>
                          <a:cs typeface="Times New Roman"/>
                        </a:rPr>
                        <a:t>α</a:t>
                      </a: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-D-Lact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B3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Melibi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 marR="94615">
                        <a:lnSpc>
                          <a:spcPct val="97000"/>
                        </a:lnSpc>
                        <a:spcAft>
                          <a:spcPts val="15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B4 </a:t>
                      </a:r>
                      <a:r>
                        <a:rPr lang="en-US" sz="500" b="1">
                          <a:latin typeface="Times New Roman"/>
                          <a:ea typeface="Segoe UI Symbol"/>
                          <a:cs typeface="Times New Roman"/>
                        </a:rPr>
                        <a:t>β</a:t>
                      </a: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-Methyl-DGlucosid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B5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Salicin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B6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N-Acetyl-DGlucosamin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B7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1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N-Acetyl-</a:t>
                      </a:r>
                      <a:r>
                        <a:rPr lang="en-US" sz="500" b="1">
                          <a:latin typeface="Times New Roman"/>
                          <a:ea typeface="Segoe UI Symbol"/>
                          <a:cs typeface="Times New Roman"/>
                        </a:rPr>
                        <a:t>β</a:t>
                      </a: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-DMannosamin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B8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N-Acetyl-DGalactosamin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B9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N-Acetyl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Neuramin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B10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1% NaCl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B11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4% NaCl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 dirty="0">
                          <a:latin typeface="Times New Roman"/>
                          <a:ea typeface="Times New Roman"/>
                          <a:cs typeface="Times New Roman"/>
                        </a:rPr>
                        <a:t>B12 </a:t>
                      </a:r>
                      <a:endParaRPr lang="en-US" sz="1100" dirty="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 dirty="0">
                          <a:latin typeface="Times New Roman"/>
                          <a:ea typeface="Times New Roman"/>
                          <a:cs typeface="Times New Roman"/>
                        </a:rPr>
                        <a:t>8% </a:t>
                      </a:r>
                      <a:r>
                        <a:rPr lang="en-US" sz="500" b="1" dirty="0" err="1">
                          <a:latin typeface="Times New Roman"/>
                          <a:ea typeface="Times New Roman"/>
                          <a:cs typeface="Times New Roman"/>
                        </a:rPr>
                        <a:t>NaCl</a:t>
                      </a:r>
                      <a:r>
                        <a:rPr lang="en-US" sz="500" b="1" dirty="0">
                          <a:latin typeface="Times New Roman"/>
                          <a:ea typeface="Times New Roman"/>
                          <a:cs typeface="Times New Roman"/>
                        </a:rPr>
                        <a:t> </a:t>
                      </a:r>
                      <a:endParaRPr lang="en-U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</a:tr>
              <a:tr h="588146"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 dirty="0">
                          <a:latin typeface="Times New Roman"/>
                          <a:ea typeface="Times New Roman"/>
                          <a:cs typeface="Times New Roman"/>
                        </a:rPr>
                        <a:t>C1 </a:t>
                      </a:r>
                      <a:endParaRPr lang="en-US" sz="1100" dirty="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 dirty="0">
                          <a:latin typeface="Times New Roman"/>
                          <a:ea typeface="Segoe UI Symbol"/>
                          <a:cs typeface="Times New Roman"/>
                        </a:rPr>
                        <a:t>α</a:t>
                      </a:r>
                      <a:r>
                        <a:rPr lang="en-US" sz="500" b="1" dirty="0">
                          <a:latin typeface="Times New Roman"/>
                          <a:ea typeface="Times New Roman"/>
                          <a:cs typeface="Times New Roman"/>
                        </a:rPr>
                        <a:t>-D-Glucose </a:t>
                      </a:r>
                      <a:endParaRPr lang="en-U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C2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Mann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C3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Fruct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399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C4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Galact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C5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3-Methyl Glucose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C6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Fuc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C7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-Fuc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C8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-Rhamnos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C9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Inosin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C10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1% Sodium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actat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C11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usid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C12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Serin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</a:tr>
              <a:tr h="589032"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1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Sorbitol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2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Mannitol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399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3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Arabitol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4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myo-Inositol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399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5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lycerol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399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6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Glucose- 6-PO4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7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Fructose- 6-PO4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8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Aspart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9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Serin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10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Troleandomycin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11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Rifamycin SV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12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Minocyclin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</a:tr>
              <a:tr h="588146"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E1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elatin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E2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lycyl-L-Prolin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E3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-Alanin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E4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-Arginin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E5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-Aspart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E6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-Glutam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E7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-Histidin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E8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-Pyroglutamic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E9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-Serin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E10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incomycin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E11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uanidine HCl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E12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Niaproof 4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</a:tr>
              <a:tr h="588146"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1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Pectin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2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Galacturonic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3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-Galactonic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cid Lacton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4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Glucon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399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5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Glucuronic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6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lucuronamid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7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Muc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8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Quin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9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Sacchar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10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Vancomycin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11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Tetrazolium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Violet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399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12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Tetrazolium  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Blu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</a:tr>
              <a:tr h="589032">
                <a:tc>
                  <a:txBody>
                    <a:bodyPr/>
                    <a:lstStyle/>
                    <a:p>
                      <a:pPr marL="1270" marR="10160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1 p-Hydroxy- Phenylacetic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2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Methyl Pyruvat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3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Lact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Methyl Ester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4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-Lact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5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Citr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6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Segoe UI Symbol"/>
                          <a:cs typeface="Times New Roman"/>
                        </a:rPr>
                        <a:t>α</a:t>
                      </a: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-Keto-Glutaric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7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D-Mal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8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-Mal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399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9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Bromo-Succinic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10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Nalidix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11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Lithium Chlorid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G12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Potassium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Tellurit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</a:tr>
              <a:tr h="591688"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H1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Tween 40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399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H2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Segoe UI Symbol"/>
                          <a:cs typeface="Times New Roman"/>
                        </a:rPr>
                        <a:t>γ</a:t>
                      </a: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-Amino-Butryric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 marR="104140">
                        <a:lnSpc>
                          <a:spcPct val="96000"/>
                        </a:lnSpc>
                        <a:spcAft>
                          <a:spcPts val="25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H3 </a:t>
                      </a:r>
                      <a:r>
                        <a:rPr lang="en-US" sz="500" b="1">
                          <a:latin typeface="Times New Roman"/>
                          <a:ea typeface="Segoe UI Symbol"/>
                          <a:cs typeface="Times New Roman"/>
                        </a:rPr>
                        <a:t>α</a:t>
                      </a: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-HydroxyButyr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5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H4 β-Hydroxy-D,LButyr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399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H5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Segoe UI Symbol"/>
                          <a:cs typeface="Times New Roman"/>
                        </a:rPr>
                        <a:t>α</a:t>
                      </a: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-Keto-Butyric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H6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cetoacetic Acid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H7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Propion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399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H8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cet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399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H9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Formic Acid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H10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Aztreonam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H11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>
                          <a:latin typeface="Times New Roman"/>
                          <a:ea typeface="Times New Roman"/>
                          <a:cs typeface="Times New Roman"/>
                        </a:rPr>
                        <a:t>Sodium Butyrate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  <a:tc>
                  <a:txBody>
                    <a:bodyPr/>
                    <a:lstStyle/>
                    <a:p>
                      <a:pPr marL="127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 dirty="0">
                          <a:latin typeface="Times New Roman"/>
                          <a:ea typeface="Times New Roman"/>
                          <a:cs typeface="Times New Roman"/>
                        </a:rPr>
                        <a:t>H12 </a:t>
                      </a:r>
                      <a:endParaRPr lang="en-US" sz="1100" dirty="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127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500" b="1" dirty="0">
                          <a:latin typeface="Times New Roman"/>
                          <a:ea typeface="Times New Roman"/>
                          <a:cs typeface="Times New Roman"/>
                        </a:rPr>
                        <a:t>Sodium </a:t>
                      </a:r>
                      <a:r>
                        <a:rPr lang="en-US" sz="500" b="1" dirty="0" err="1">
                          <a:latin typeface="Times New Roman"/>
                          <a:ea typeface="Times New Roman"/>
                          <a:cs typeface="Times New Roman"/>
                        </a:rPr>
                        <a:t>Bromate</a:t>
                      </a:r>
                      <a:r>
                        <a:rPr lang="en-US" sz="500" b="1" dirty="0">
                          <a:latin typeface="Times New Roman"/>
                          <a:ea typeface="Times New Roman"/>
                          <a:cs typeface="Times New Roman"/>
                        </a:rPr>
                        <a:t> </a:t>
                      </a:r>
                      <a:endParaRPr lang="en-U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17780" marR="12700" marT="1587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E5"/>
                    </a:solidFill>
                  </a:tcPr>
                </a:tc>
              </a:tr>
            </a:tbl>
          </a:graphicData>
        </a:graphic>
      </p:graphicFrame>
      <p:grpSp>
        <p:nvGrpSpPr>
          <p:cNvPr id="14" name="Group 13"/>
          <p:cNvGrpSpPr/>
          <p:nvPr/>
        </p:nvGrpSpPr>
        <p:grpSpPr>
          <a:xfrm>
            <a:off x="1643042" y="5407239"/>
            <a:ext cx="3885339" cy="1022157"/>
            <a:chOff x="1643042" y="5407239"/>
            <a:chExt cx="3885339" cy="1022157"/>
          </a:xfrm>
        </p:grpSpPr>
        <p:grpSp>
          <p:nvGrpSpPr>
            <p:cNvPr id="7" name="Group 6"/>
            <p:cNvGrpSpPr/>
            <p:nvPr/>
          </p:nvGrpSpPr>
          <p:grpSpPr>
            <a:xfrm>
              <a:off x="1662094" y="5407239"/>
              <a:ext cx="2811892" cy="307777"/>
              <a:chOff x="1590656" y="5345684"/>
              <a:chExt cx="2811892" cy="307777"/>
            </a:xfrm>
          </p:grpSpPr>
          <p:sp>
            <p:nvSpPr>
              <p:cNvPr id="1025" name="Rectangle 3"/>
              <p:cNvSpPr>
                <a:spLocks noChangeArrowheads="1"/>
              </p:cNvSpPr>
              <p:nvPr/>
            </p:nvSpPr>
            <p:spPr bwMode="auto">
              <a:xfrm>
                <a:off x="1590656" y="5429264"/>
                <a:ext cx="266700" cy="152400"/>
              </a:xfrm>
              <a:prstGeom prst="rect">
                <a:avLst/>
              </a:prstGeom>
              <a:solidFill>
                <a:srgbClr val="FF3399"/>
              </a:solidFill>
              <a:ln w="12700">
                <a:solidFill>
                  <a:srgbClr val="FF3399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1928794" y="5345684"/>
                <a:ext cx="2473754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>
                    <a:latin typeface="Times New Roman" pitchFamily="18" charset="0"/>
                    <a:cs typeface="Times New Roman" pitchFamily="18" charset="0"/>
                  </a:rPr>
                  <a:t>Substrate utilized (Positive test)</a:t>
                </a:r>
              </a:p>
            </p:txBody>
          </p:sp>
        </p:grpSp>
        <p:sp>
          <p:nvSpPr>
            <p:cNvPr id="1026" name="Rectangle 4"/>
            <p:cNvSpPr>
              <a:spLocks noChangeArrowheads="1"/>
            </p:cNvSpPr>
            <p:nvPr/>
          </p:nvSpPr>
          <p:spPr bwMode="auto">
            <a:xfrm>
              <a:off x="1662094" y="5857892"/>
              <a:ext cx="266700" cy="152400"/>
            </a:xfrm>
            <a:prstGeom prst="rect">
              <a:avLst/>
            </a:prstGeom>
            <a:solidFill>
              <a:srgbClr val="00B0F0"/>
            </a:solidFill>
            <a:ln w="12700">
              <a:solidFill>
                <a:srgbClr val="00B0F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Rectangle 8"/>
            <p:cNvSpPr/>
            <p:nvPr/>
          </p:nvSpPr>
          <p:spPr>
            <a:xfrm>
              <a:off x="1990168" y="5764429"/>
              <a:ext cx="353821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Partially utilized substrate (Weak positive test)</a:t>
              </a:r>
            </a:p>
          </p:txBody>
        </p:sp>
        <p:sp>
          <p:nvSpPr>
            <p:cNvPr id="1027" name="Rectangle 5"/>
            <p:cNvSpPr>
              <a:spLocks noChangeArrowheads="1"/>
            </p:cNvSpPr>
            <p:nvPr/>
          </p:nvSpPr>
          <p:spPr bwMode="auto">
            <a:xfrm>
              <a:off x="1643042" y="6205558"/>
              <a:ext cx="266700" cy="152400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2000232" y="6121619"/>
              <a:ext cx="277992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No substrate utilized (Negative test)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275</Words>
  <Application>Microsoft Office PowerPoint</Application>
  <PresentationFormat>On-screen Show (4:3)</PresentationFormat>
  <Paragraphs>20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P</dc:creator>
  <cp:lastModifiedBy>HP</cp:lastModifiedBy>
  <cp:revision>2</cp:revision>
  <dcterms:created xsi:type="dcterms:W3CDTF">2022-12-14T06:55:22Z</dcterms:created>
  <dcterms:modified xsi:type="dcterms:W3CDTF">2022-12-14T07:17:34Z</dcterms:modified>
</cp:coreProperties>
</file>